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sldIdLst>
    <p:sldId id="25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3" d="100"/>
          <a:sy n="73" d="100"/>
        </p:scale>
        <p:origin x="325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mmond, John - REE-ARS" userId="c4636370-9abd-41f3-81dc-0529d80fa84a" providerId="ADAL" clId="{B8129641-1D1B-4E09-AF9D-C7123F25E26E}"/>
    <pc:docChg chg="modSld">
      <pc:chgData name="Hammond, John - REE-ARS" userId="c4636370-9abd-41f3-81dc-0529d80fa84a" providerId="ADAL" clId="{B8129641-1D1B-4E09-AF9D-C7123F25E26E}" dt="2025-03-09T19:22:27.186" v="4" actId="13926"/>
      <pc:docMkLst>
        <pc:docMk/>
      </pc:docMkLst>
      <pc:sldChg chg="modSp mod">
        <pc:chgData name="Hammond, John - REE-ARS" userId="c4636370-9abd-41f3-81dc-0529d80fa84a" providerId="ADAL" clId="{B8129641-1D1B-4E09-AF9D-C7123F25E26E}" dt="2025-03-09T19:22:27.186" v="4" actId="13926"/>
        <pc:sldMkLst>
          <pc:docMk/>
          <pc:sldMk cId="1813950906" sldId="256"/>
        </pc:sldMkLst>
        <pc:spChg chg="mod">
          <ac:chgData name="Hammond, John - REE-ARS" userId="c4636370-9abd-41f3-81dc-0529d80fa84a" providerId="ADAL" clId="{B8129641-1D1B-4E09-AF9D-C7123F25E26E}" dt="2025-03-09T19:22:27.186" v="4" actId="13926"/>
          <ac:spMkLst>
            <pc:docMk/>
            <pc:sldMk cId="1813950906" sldId="256"/>
            <ac:spMk id="6" creationId="{7FC14156-F36A-327B-177E-9525E0B5005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AB558-2723-42ED-9256-7F6C963322D7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BEA8-9EB5-4D84-B855-D4C2009F69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43212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AB558-2723-42ED-9256-7F6C963322D7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BEA8-9EB5-4D84-B855-D4C2009F69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18158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AB558-2723-42ED-9256-7F6C963322D7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BEA8-9EB5-4D84-B855-D4C2009F69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008802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AB558-2723-42ED-9256-7F6C963322D7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BEA8-9EB5-4D84-B855-D4C2009F69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81782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AB558-2723-42ED-9256-7F6C963322D7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BEA8-9EB5-4D84-B855-D4C2009F69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33690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AB558-2723-42ED-9256-7F6C963322D7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BEA8-9EB5-4D84-B855-D4C2009F69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9895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AB558-2723-42ED-9256-7F6C963322D7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BEA8-9EB5-4D84-B855-D4C2009F69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5613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AB558-2723-42ED-9256-7F6C963322D7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BEA8-9EB5-4D84-B855-D4C2009F69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34147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AB558-2723-42ED-9256-7F6C963322D7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BEA8-9EB5-4D84-B855-D4C2009F69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26327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AB558-2723-42ED-9256-7F6C963322D7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BEA8-9EB5-4D84-B855-D4C2009F69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29896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4AB558-2723-42ED-9256-7F6C963322D7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BEA8-9EB5-4D84-B855-D4C2009F69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352068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E4AB558-2723-42ED-9256-7F6C963322D7}" type="datetimeFigureOut">
              <a:rPr lang="it-IT" smtClean="0"/>
              <a:t>17/03/2025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44BEA8-9EB5-4D84-B855-D4C2009F695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443911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CasellaDiTesto 5">
            <a:extLst>
              <a:ext uri="{FF2B5EF4-FFF2-40B4-BE49-F238E27FC236}">
                <a16:creationId xmlns:a16="http://schemas.microsoft.com/office/drawing/2014/main" id="{7FC14156-F36A-327B-177E-9525E0B50059}"/>
              </a:ext>
            </a:extLst>
          </p:cNvPr>
          <p:cNvSpPr txBox="1"/>
          <p:nvPr/>
        </p:nvSpPr>
        <p:spPr>
          <a:xfrm>
            <a:off x="392424" y="6820164"/>
            <a:ext cx="5922976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800" b="1" dirty="0">
                <a:latin typeface="Times New Roman"/>
                <a:cs typeface="Times New Roman"/>
              </a:rPr>
              <a:t>Figure S4.</a:t>
            </a:r>
            <a:r>
              <a:rPr lang="en-US" sz="1800" dirty="0">
                <a:latin typeface="Times New Roman"/>
                <a:cs typeface="Times New Roman"/>
              </a:rPr>
              <a:t> Similarity matrix of nucleocapsid amino acid sequences of selected viral species listed in the </a:t>
            </a:r>
            <a:r>
              <a:rPr lang="en-US" sz="1800" i="1" dirty="0" err="1">
                <a:latin typeface="Times New Roman"/>
                <a:cs typeface="Times New Roman"/>
              </a:rPr>
              <a:t>Hareavirales</a:t>
            </a:r>
            <a:r>
              <a:rPr lang="en-US" sz="1800" dirty="0">
                <a:latin typeface="Times New Roman"/>
                <a:cs typeface="Times New Roman"/>
              </a:rPr>
              <a:t> order, the official species and the newly discovered species possibly listing in the </a:t>
            </a:r>
            <a:r>
              <a:rPr lang="en-US" sz="1800" i="1" dirty="0">
                <a:latin typeface="Times New Roman"/>
                <a:cs typeface="Times New Roman"/>
              </a:rPr>
              <a:t>Konkoviridae</a:t>
            </a:r>
            <a:r>
              <a:rPr lang="en-US" sz="1800" dirty="0">
                <a:latin typeface="Times New Roman"/>
                <a:cs typeface="Times New Roman"/>
              </a:rPr>
              <a:t> family (for which the RNA-2 full CDS has been obtained), obtained by Sequence Demarcation Tool (SDT) v.1.2</a:t>
            </a:r>
            <a:endParaRPr lang="it-IT" sz="1800" dirty="0">
              <a:solidFill>
                <a:srgbClr val="FF0000"/>
              </a:solidFill>
              <a:latin typeface="Times New Roman"/>
              <a:cs typeface="Times New Roman"/>
            </a:endParaRPr>
          </a:p>
        </p:txBody>
      </p:sp>
      <p:pic>
        <p:nvPicPr>
          <p:cNvPr id="3" name="Immagine 2" descr="Immagine che contiene testo, schermata, linea, Policromia&#10;&#10;Il contenuto generato dall'IA potrebbe non essere corretto.">
            <a:extLst>
              <a:ext uri="{FF2B5EF4-FFF2-40B4-BE49-F238E27FC236}">
                <a16:creationId xmlns:a16="http://schemas.microsoft.com/office/drawing/2014/main" id="{B1722690-CD5A-B2DB-6887-5AFBEB832F8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512" y="1204153"/>
            <a:ext cx="5772801" cy="50137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395090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Tema di 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dc1a3a29-1734-4967-8cff-d351e6fc4f0c" xsi:nil="true"/>
    <lcf76f155ced4ddcb4097134ff3c332f xmlns="78083c92-0af9-4662-99b5-5fe34061947b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D3896766B253BF4C954DE14C4319FB08" ma:contentTypeVersion="11" ma:contentTypeDescription="Creare un nuovo documento." ma:contentTypeScope="" ma:versionID="55f3245f08a521eb9542d035c68db22e">
  <xsd:schema xmlns:xsd="http://www.w3.org/2001/XMLSchema" xmlns:xs="http://www.w3.org/2001/XMLSchema" xmlns:p="http://schemas.microsoft.com/office/2006/metadata/properties" xmlns:ns2="78083c92-0af9-4662-99b5-5fe34061947b" xmlns:ns3="dc1a3a29-1734-4967-8cff-d351e6fc4f0c" targetNamespace="http://schemas.microsoft.com/office/2006/metadata/properties" ma:root="true" ma:fieldsID="b9c0ba933e2b573af2568ceb043f1f1b" ns2:_="" ns3:_="">
    <xsd:import namespace="78083c92-0af9-4662-99b5-5fe34061947b"/>
    <xsd:import namespace="dc1a3a29-1734-4967-8cff-d351e6fc4f0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SearchProperties" minOccurs="0"/>
                <xsd:element ref="ns2:MediaServiceObjectDetectorVersion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83c92-0af9-4662-99b5-5fe34061947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SearchProperties" ma:index="1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ObjectDetectorVersions" ma:index="11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3" nillable="true" ma:taxonomy="true" ma:internalName="lcf76f155ced4ddcb4097134ff3c332f" ma:taxonomyFieldName="MediaServiceImageTags" ma:displayName="Tag immagine" ma:readOnly="false" ma:fieldId="{5cf76f15-5ced-4ddc-b409-7134ff3c332f}" ma:taxonomyMulti="true" ma:sspId="e5505f8f-da62-40e5-a116-f08e7003152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dc1a3a29-1734-4967-8cff-d351e6fc4f0c" elementFormDefault="qualified">
    <xsd:import namespace="http://schemas.microsoft.com/office/2006/documentManagement/types"/>
    <xsd:import namespace="http://schemas.microsoft.com/office/infopath/2007/PartnerControls"/>
    <xsd:element name="TaxCatchAll" ma:index="14" nillable="true" ma:displayName="Taxonomy Catch All Column" ma:hidden="true" ma:list="{e8a6735f-476e-414a-bdf7-a56c8e7d8966}" ma:internalName="TaxCatchAll" ma:showField="CatchAllData" ma:web="dc1a3a29-1734-4967-8cff-d351e6fc4f0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F9D8C6C3-8CE2-408A-A028-137ED5359F20}">
  <ds:schemaRefs>
    <ds:schemaRef ds:uri="http://schemas.microsoft.com/office/2006/metadata/properties"/>
    <ds:schemaRef ds:uri="http://schemas.microsoft.com/office/infopath/2007/PartnerControls"/>
    <ds:schemaRef ds:uri="dc1a3a29-1734-4967-8cff-d351e6fc4f0c"/>
    <ds:schemaRef ds:uri="78083c92-0af9-4662-99b5-5fe34061947b"/>
  </ds:schemaRefs>
</ds:datastoreItem>
</file>

<file path=customXml/itemProps2.xml><?xml version="1.0" encoding="utf-8"?>
<ds:datastoreItem xmlns:ds="http://schemas.openxmlformats.org/officeDocument/2006/customXml" ds:itemID="{647345C0-4182-4A40-9A97-0ADCA716B506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6AECBFBE-267A-4C26-921D-DD339B6270D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83c92-0af9-4662-99b5-5fe34061947b"/>
    <ds:schemaRef ds:uri="dc1a3a29-1734-4967-8cff-d351e6fc4f0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56</Words>
  <Application>Microsoft Office PowerPoint</Application>
  <PresentationFormat>A4 (21x29,7 cm)</PresentationFormat>
  <Paragraphs>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AURA MIOZZI</dc:creator>
  <cp:lastModifiedBy>LAURA MIOZZI</cp:lastModifiedBy>
  <cp:revision>4</cp:revision>
  <dcterms:created xsi:type="dcterms:W3CDTF">2025-03-05T14:35:11Z</dcterms:created>
  <dcterms:modified xsi:type="dcterms:W3CDTF">2025-03-17T10:31:1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D3896766B253BF4C954DE14C4319FB08</vt:lpwstr>
  </property>
</Properties>
</file>